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907588" cy="6858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35600" cy="9867600"/>
          </a:xfrm>
          <a:prstGeom prst="rect">
            <a:avLst/>
          </a:prstGeom>
          <a:solidFill>
            <a:srgbClr val="ffffff"/>
          </a:solidFill>
          <a:ln w="936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0" y="0"/>
            <a:ext cx="6735600" cy="9867960"/>
          </a:xfrm>
          <a:custGeom>
            <a:avLst/>
            <a:gdLst>
              <a:gd name="textAreaLeft" fmla="*/ 360 w 6735600"/>
              <a:gd name="textAreaRight" fmla="*/ 6735240 w 6735600"/>
              <a:gd name="textAreaTop" fmla="*/ 360 h 9867960"/>
              <a:gd name="textAreaBottom" fmla="*/ 9867600 h 9867960"/>
            </a:gdLst>
            <a:ahLst/>
            <a:rect l="textAreaLeft" t="textAreaTop" r="textAreaRight" b="textAreaBottom"/>
            <a:pathLst>
              <a:path w="21600" h="31644">
                <a:moveTo>
                  <a:pt x="5" y="0"/>
                </a:moveTo>
                <a:arcTo wR="5" hR="5" stAng="16200000" swAng="-5400000"/>
                <a:lnTo>
                  <a:pt x="0" y="31639"/>
                </a:lnTo>
                <a:arcTo wR="5" hR="5" stAng="10800000" swAng="-5400000"/>
                <a:lnTo>
                  <a:pt x="21595" y="31644"/>
                </a:lnTo>
                <a:arcTo wR="5" hR="5" stAng="5400000" swAng="-5400000"/>
                <a:lnTo>
                  <a:pt x="21600" y="5"/>
                </a:lnTo>
                <a:arcTo wR="5" hR="5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0" y="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814920" y="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1"/>
          <p:cNvSpPr>
            <a:spLocks noGrp="1"/>
          </p:cNvSpPr>
          <p:nvPr>
            <p:ph type="sldImg"/>
          </p:nvPr>
        </p:nvSpPr>
        <p:spPr>
          <a:xfrm>
            <a:off x="695160" y="739440"/>
            <a:ext cx="5343840" cy="369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2"/>
          <p:cNvSpPr>
            <a:spLocks noGrp="1"/>
          </p:cNvSpPr>
          <p:nvPr>
            <p:ph type="body"/>
          </p:nvPr>
        </p:nvSpPr>
        <p:spPr>
          <a:xfrm>
            <a:off x="673200" y="4686120"/>
            <a:ext cx="5387760" cy="443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0" y="937116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 type="sldNum" idx="2"/>
          </p:nvPr>
        </p:nvSpPr>
        <p:spPr>
          <a:xfrm>
            <a:off x="3814560" y="9370800"/>
            <a:ext cx="2917800" cy="4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EF6DB436-31B4-47D3-ACE9-161AD08B8785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PlaceHolder 1"/>
          <p:cNvSpPr>
            <a:spLocks noGrp="1"/>
          </p:cNvSpPr>
          <p:nvPr>
            <p:ph type="sldImg"/>
          </p:nvPr>
        </p:nvSpPr>
        <p:spPr>
          <a:xfrm>
            <a:off x="695160" y="739800"/>
            <a:ext cx="5345280" cy="3700440"/>
          </a:xfrm>
          <a:prstGeom prst="rect">
            <a:avLst/>
          </a:prstGeom>
          <a:ln w="0">
            <a:noFill/>
          </a:ln>
        </p:spPr>
      </p:sp>
      <p:sp>
        <p:nvSpPr>
          <p:cNvPr id="134" name="PlaceHolder 2"/>
          <p:cNvSpPr>
            <a:spLocks noGrp="1"/>
          </p:cNvSpPr>
          <p:nvPr>
            <p:ph type="body"/>
          </p:nvPr>
        </p:nvSpPr>
        <p:spPr>
          <a:xfrm>
            <a:off x="672840" y="4686120"/>
            <a:ext cx="5389560" cy="443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>
            <a:off x="3814920" y="937116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51F9C889-6E54-4380-9F23-F90672D5F249}" type="slidenum"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2B333EF-9D06-401E-B1EF-32B56F2EED84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891360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360" y="3963600"/>
            <a:ext cx="891360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7745A0B-84DF-4D7C-859C-F3976247DAED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36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268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3E056F5-7F46-4ACD-B01C-B8D02F81DB57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280" y="16002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2840" y="16002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360" y="39636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280" y="39636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2840" y="39636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BDB39DA-B960-460F-8896-00EF39C5C49C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360" y="1600200"/>
            <a:ext cx="891360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BD3A607-CB3F-4A70-B618-571B227F5170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891360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FE75AC2-7CE4-40FB-90EA-D4B3BCCC80DA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6DB6531-97AC-4E96-8BEF-5399D2F5D066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A831D5B-2D23-40E6-809B-191DEAD6C9EE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360" y="274680"/>
            <a:ext cx="891360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FE9D375D-FE81-4CB6-B2C3-765DE9F576C2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36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443557F-274A-4634-A100-83BDFFCF8B07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268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849BAC7-3424-4223-A680-3619F1DAB359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360" y="3963600"/>
            <a:ext cx="891360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8D602BD-609F-45F1-BBEF-7BCCCEF2E260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360" y="1600200"/>
            <a:ext cx="891360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495360" y="6245280"/>
            <a:ext cx="231120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3384720" y="6245280"/>
            <a:ext cx="313668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>
          <a:xfrm>
            <a:off x="7099200" y="6245280"/>
            <a:ext cx="230976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5186102E-7C95-4D2E-B4B6-BA54CD5437CA}" type="slidenum">
              <a:rPr b="0" lang="en-US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"/>
          <p:cNvSpPr/>
          <p:nvPr/>
        </p:nvSpPr>
        <p:spPr>
          <a:xfrm>
            <a:off x="297000" y="611280"/>
            <a:ext cx="4406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stimation of the number of EG10 copie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6335640" y="1776240"/>
            <a:ext cx="488880" cy="311400"/>
          </a:xfrm>
          <a:prstGeom prst="rightArrow">
            <a:avLst>
              <a:gd name="adj1" fmla="val 64204"/>
              <a:gd name="adj2" fmla="val 26464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6824520" y="1776240"/>
            <a:ext cx="490680" cy="311400"/>
          </a:xfrm>
          <a:prstGeom prst="rightArrow">
            <a:avLst>
              <a:gd name="adj1" fmla="val 64204"/>
              <a:gd name="adj2" fmla="val 26481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7823160" y="1776240"/>
            <a:ext cx="490680" cy="311400"/>
          </a:xfrm>
          <a:prstGeom prst="rightArrow">
            <a:avLst>
              <a:gd name="adj1" fmla="val 64204"/>
              <a:gd name="adj2" fmla="val 26481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6372360" y="1847880"/>
            <a:ext cx="380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6877080" y="1847880"/>
            <a:ext cx="380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7875720" y="1847880"/>
            <a:ext cx="380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6" name=""/>
          <p:cNvCxnSpPr/>
          <p:nvPr/>
        </p:nvCxnSpPr>
        <p:spPr>
          <a:xfrm>
            <a:off x="6338880" y="1317600"/>
            <a:ext cx="2160" cy="434160"/>
          </a:xfrm>
          <a:prstGeom prst="bentConnector3">
            <a:avLst>
              <a:gd name="adj1" fmla="val 40000"/>
            </a:avLst>
          </a:prstGeom>
          <a:ln w="9360">
            <a:solidFill>
              <a:srgbClr val="000000"/>
            </a:solidFill>
            <a:round/>
          </a:ln>
        </p:spPr>
      </p:cxnSp>
      <p:cxnSp>
        <p:nvCxnSpPr>
          <p:cNvPr id="57" name=""/>
          <p:cNvCxnSpPr/>
          <p:nvPr/>
        </p:nvCxnSpPr>
        <p:spPr>
          <a:xfrm>
            <a:off x="6834240" y="1317600"/>
            <a:ext cx="2160" cy="434160"/>
          </a:xfrm>
          <a:prstGeom prst="bentConnector3">
            <a:avLst>
              <a:gd name="adj1" fmla="val 40000"/>
            </a:avLst>
          </a:prstGeom>
          <a:ln w="9360">
            <a:solidFill>
              <a:srgbClr val="000000"/>
            </a:solidFill>
            <a:round/>
          </a:ln>
        </p:spPr>
      </p:cxnSp>
      <p:cxnSp>
        <p:nvCxnSpPr>
          <p:cNvPr id="58" name=""/>
          <p:cNvCxnSpPr/>
          <p:nvPr/>
        </p:nvCxnSpPr>
        <p:spPr>
          <a:xfrm>
            <a:off x="7338600" y="1317600"/>
            <a:ext cx="2520" cy="43416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round/>
          </a:ln>
        </p:spPr>
      </p:cxnSp>
      <p:cxnSp>
        <p:nvCxnSpPr>
          <p:cNvPr id="59" name=""/>
          <p:cNvCxnSpPr/>
          <p:nvPr/>
        </p:nvCxnSpPr>
        <p:spPr>
          <a:xfrm>
            <a:off x="7813800" y="1314360"/>
            <a:ext cx="2160" cy="434160"/>
          </a:xfrm>
          <a:prstGeom prst="bentConnector3">
            <a:avLst>
              <a:gd name="adj1" fmla="val 40000"/>
            </a:avLst>
          </a:prstGeom>
          <a:ln w="9360">
            <a:solidFill>
              <a:srgbClr val="000000"/>
            </a:solidFill>
            <a:round/>
          </a:ln>
        </p:spPr>
      </p:cxnSp>
      <p:sp>
        <p:nvSpPr>
          <p:cNvPr id="60" name=""/>
          <p:cNvSpPr/>
          <p:nvPr/>
        </p:nvSpPr>
        <p:spPr>
          <a:xfrm>
            <a:off x="704880" y="1320840"/>
            <a:ext cx="49338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One intact copy has normal head-to-tail junctions (NJs) at both ends. When number of the NJs is n, number of the intact copies is n-1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6190200" y="1052640"/>
            <a:ext cx="45648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J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2" name=""/>
          <p:cNvCxnSpPr/>
          <p:nvPr/>
        </p:nvCxnSpPr>
        <p:spPr>
          <a:xfrm>
            <a:off x="8268840" y="1314360"/>
            <a:ext cx="2520" cy="43416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round/>
          </a:ln>
        </p:spPr>
      </p:cxnSp>
      <p:sp>
        <p:nvSpPr>
          <p:cNvPr id="63" name=""/>
          <p:cNvSpPr/>
          <p:nvPr/>
        </p:nvSpPr>
        <p:spPr>
          <a:xfrm>
            <a:off x="6669360" y="1052640"/>
            <a:ext cx="45648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J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7121880" y="1052640"/>
            <a:ext cx="45648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J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7650000" y="1052640"/>
            <a:ext cx="5493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J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n-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8147520" y="1052640"/>
            <a:ext cx="45648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J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flipV="1" rot="16200000">
            <a:off x="7208640" y="1291320"/>
            <a:ext cx="235080" cy="1968480"/>
          </a:xfrm>
          <a:custGeom>
            <a:avLst/>
            <a:gdLst>
              <a:gd name="textAreaLeft" fmla="*/ 150120 w 235080"/>
              <a:gd name="textAreaRight" fmla="*/ 235440 w 235080"/>
              <a:gd name="textAreaTop" fmla="*/ 15480 h 1968480"/>
              <a:gd name="textAreaBottom" fmla="*/ 1953000 h 19684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275"/>
                  <a:pt x="10800" y="549"/>
                </a:cubicBezTo>
                <a:lnTo>
                  <a:pt x="10800" y="10251"/>
                </a:lnTo>
                <a:cubicBezTo>
                  <a:pt x="10800" y="10526"/>
                  <a:pt x="5400" y="10800"/>
                  <a:pt x="0" y="10800"/>
                </a:cubicBezTo>
                <a:cubicBezTo>
                  <a:pt x="5400" y="10800"/>
                  <a:pt x="10800" y="11075"/>
                  <a:pt x="10800" y="11349"/>
                </a:cubicBezTo>
                <a:lnTo>
                  <a:pt x="10800" y="21051"/>
                </a:lnTo>
                <a:cubicBezTo>
                  <a:pt x="10800" y="21326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6327720" y="2349360"/>
            <a:ext cx="194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ntact copy number is n-1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7526160" y="1197000"/>
            <a:ext cx="144720" cy="1440"/>
          </a:xfrm>
          <a:prstGeom prst="line">
            <a:avLst/>
          </a:prstGeom>
          <a:ln w="1908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5842080" y="3645000"/>
            <a:ext cx="488880" cy="311040"/>
          </a:xfrm>
          <a:prstGeom prst="rightArrow">
            <a:avLst>
              <a:gd name="adj1" fmla="val 64204"/>
              <a:gd name="adj2" fmla="val 26494"/>
            </a:avLst>
          </a:prstGeom>
          <a:solidFill>
            <a:srgbClr val="f2f2f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flipH="1">
            <a:off x="6335640" y="3645000"/>
            <a:ext cx="488880" cy="311040"/>
          </a:xfrm>
          <a:prstGeom prst="rightArrow">
            <a:avLst>
              <a:gd name="adj1" fmla="val 64204"/>
              <a:gd name="adj2" fmla="val 26494"/>
            </a:avLst>
          </a:prstGeom>
          <a:solidFill>
            <a:srgbClr val="f2f2f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6834240" y="3645000"/>
            <a:ext cx="504720" cy="311040"/>
          </a:xfrm>
          <a:prstGeom prst="rightArrow">
            <a:avLst>
              <a:gd name="adj1" fmla="val 64204"/>
              <a:gd name="adj2" fmla="val 26496"/>
            </a:avLst>
          </a:prstGeom>
          <a:solidFill>
            <a:srgbClr val="f2f2f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7862760" y="3645000"/>
            <a:ext cx="336600" cy="311040"/>
          </a:xfrm>
          <a:prstGeom prst="rightArrow">
            <a:avLst>
              <a:gd name="adj1" fmla="val 64204"/>
              <a:gd name="adj2" fmla="val 26503"/>
            </a:avLst>
          </a:prstGeom>
          <a:solidFill>
            <a:srgbClr val="f2f2f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5954760" y="3716280"/>
            <a:ext cx="380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flipV="1">
            <a:off x="6372360" y="3716280"/>
            <a:ext cx="380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6829560" y="3716280"/>
            <a:ext cx="379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7872480" y="3716280"/>
            <a:ext cx="380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8" name=""/>
          <p:cNvCxnSpPr/>
          <p:nvPr/>
        </p:nvCxnSpPr>
        <p:spPr>
          <a:xfrm>
            <a:off x="6338880" y="3189240"/>
            <a:ext cx="2160" cy="434160"/>
          </a:xfrm>
          <a:prstGeom prst="bentConnector3">
            <a:avLst>
              <a:gd name="adj1" fmla="val 40000"/>
            </a:avLst>
          </a:prstGeom>
          <a:ln w="9360">
            <a:solidFill>
              <a:srgbClr val="000000"/>
            </a:solidFill>
            <a:round/>
          </a:ln>
        </p:spPr>
      </p:cxnSp>
      <p:cxnSp>
        <p:nvCxnSpPr>
          <p:cNvPr id="79" name=""/>
          <p:cNvCxnSpPr/>
          <p:nvPr/>
        </p:nvCxnSpPr>
        <p:spPr>
          <a:xfrm>
            <a:off x="6834240" y="3189240"/>
            <a:ext cx="2160" cy="434160"/>
          </a:xfrm>
          <a:prstGeom prst="bentConnector3">
            <a:avLst>
              <a:gd name="adj1" fmla="val 40000"/>
            </a:avLst>
          </a:prstGeom>
          <a:ln w="9360">
            <a:solidFill>
              <a:srgbClr val="000000"/>
            </a:solidFill>
            <a:round/>
          </a:ln>
        </p:spPr>
      </p:cxnSp>
      <p:cxnSp>
        <p:nvCxnSpPr>
          <p:cNvPr id="80" name=""/>
          <p:cNvCxnSpPr/>
          <p:nvPr/>
        </p:nvCxnSpPr>
        <p:spPr>
          <a:xfrm>
            <a:off x="7338600" y="3189240"/>
            <a:ext cx="2520" cy="43416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round/>
          </a:ln>
        </p:spPr>
      </p:cxnSp>
      <p:cxnSp>
        <p:nvCxnSpPr>
          <p:cNvPr id="81" name=""/>
          <p:cNvCxnSpPr/>
          <p:nvPr/>
        </p:nvCxnSpPr>
        <p:spPr>
          <a:xfrm>
            <a:off x="7846560" y="3186000"/>
            <a:ext cx="2520" cy="43416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round/>
          </a:ln>
        </p:spPr>
      </p:cxnSp>
      <p:sp>
        <p:nvSpPr>
          <p:cNvPr id="82" name=""/>
          <p:cNvSpPr/>
          <p:nvPr/>
        </p:nvSpPr>
        <p:spPr>
          <a:xfrm>
            <a:off x="704880" y="3048120"/>
            <a:ext cx="49338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One rearrangement copy has an abnormal junction (AJ) at least one end. When number of the AJ is m, number of the rearranged inactive copies is m+1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6188040" y="2905200"/>
            <a:ext cx="44748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J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8224920" y="3645000"/>
            <a:ext cx="488880" cy="311040"/>
          </a:xfrm>
          <a:prstGeom prst="rightArrow">
            <a:avLst>
              <a:gd name="adj1" fmla="val 64204"/>
              <a:gd name="adj2" fmla="val 26494"/>
            </a:avLst>
          </a:prstGeom>
          <a:solidFill>
            <a:srgbClr val="f2f2f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8180280" y="3716280"/>
            <a:ext cx="3812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6" name=""/>
          <p:cNvCxnSpPr/>
          <p:nvPr/>
        </p:nvCxnSpPr>
        <p:spPr>
          <a:xfrm>
            <a:off x="8190000" y="3186000"/>
            <a:ext cx="2160" cy="434160"/>
          </a:xfrm>
          <a:prstGeom prst="bentConnector3">
            <a:avLst>
              <a:gd name="adj1" fmla="val 40000"/>
            </a:avLst>
          </a:prstGeom>
          <a:ln w="9360">
            <a:solidFill>
              <a:srgbClr val="000000"/>
            </a:solidFill>
            <a:round/>
          </a:ln>
        </p:spPr>
      </p:cxnSp>
      <p:sp>
        <p:nvSpPr>
          <p:cNvPr id="87" name=""/>
          <p:cNvSpPr/>
          <p:nvPr/>
        </p:nvSpPr>
        <p:spPr>
          <a:xfrm>
            <a:off x="6667560" y="2905200"/>
            <a:ext cx="44748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J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7121520" y="2905200"/>
            <a:ext cx="44748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J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7639200" y="2905200"/>
            <a:ext cx="51912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j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m-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8086680" y="2905200"/>
            <a:ext cx="47628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J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flipV="1" rot="16200000">
            <a:off x="7171200" y="2701800"/>
            <a:ext cx="233640" cy="2889360"/>
          </a:xfrm>
          <a:custGeom>
            <a:avLst/>
            <a:gdLst>
              <a:gd name="textAreaLeft" fmla="*/ 149400 w 233640"/>
              <a:gd name="textAreaRight" fmla="*/ 234000 w 233640"/>
              <a:gd name="textAreaTop" fmla="*/ 15480 h 2889360"/>
              <a:gd name="textAreaBottom" fmla="*/ 2873880 h 28893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86"/>
                  <a:pt x="10800" y="372"/>
                </a:cubicBezTo>
                <a:lnTo>
                  <a:pt x="10800" y="10428"/>
                </a:lnTo>
                <a:cubicBezTo>
                  <a:pt x="10800" y="10614"/>
                  <a:pt x="5400" y="10800"/>
                  <a:pt x="0" y="10800"/>
                </a:cubicBezTo>
                <a:cubicBezTo>
                  <a:pt x="5400" y="10800"/>
                  <a:pt x="10800" y="10986"/>
                  <a:pt x="10800" y="11172"/>
                </a:cubicBezTo>
                <a:lnTo>
                  <a:pt x="10800" y="21228"/>
                </a:lnTo>
                <a:cubicBezTo>
                  <a:pt x="10800" y="21414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6111720" y="4183200"/>
            <a:ext cx="2298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bnormal copy number is m+1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7535880" y="3049560"/>
            <a:ext cx="144360" cy="1440"/>
          </a:xfrm>
          <a:prstGeom prst="line">
            <a:avLst/>
          </a:prstGeom>
          <a:ln w="1908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704880" y="4875120"/>
            <a:ext cx="504036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f one AJ is inserted between NJs, one intact copy decreases. Thus, when NJs and AJs are mixed, the maximum and minimum numbers of the intact copies are calculated as n-1 and (n-1)-m, respectively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7613640" y="5719680"/>
            <a:ext cx="325440" cy="459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7832880" y="5767560"/>
            <a:ext cx="245880" cy="312480"/>
          </a:xfrm>
          <a:prstGeom prst="rightArrow">
            <a:avLst>
              <a:gd name="adj1" fmla="val 64204"/>
              <a:gd name="adj2" fmla="val 26491"/>
            </a:avLst>
          </a:prstGeom>
          <a:solidFill>
            <a:srgbClr val="f2f2f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8086680" y="5767560"/>
            <a:ext cx="239760" cy="312480"/>
          </a:xfrm>
          <a:prstGeom prst="rightArrow">
            <a:avLst>
              <a:gd name="adj1" fmla="val 64204"/>
              <a:gd name="adj2" fmla="val 26491"/>
            </a:avLst>
          </a:prstGeom>
          <a:solidFill>
            <a:srgbClr val="f2f2f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8020080" y="5837400"/>
            <a:ext cx="380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9" name=""/>
          <p:cNvCxnSpPr/>
          <p:nvPr/>
        </p:nvCxnSpPr>
        <p:spPr>
          <a:xfrm>
            <a:off x="7826400" y="5308560"/>
            <a:ext cx="2160" cy="434160"/>
          </a:xfrm>
          <a:prstGeom prst="bentConnector3">
            <a:avLst>
              <a:gd name="adj1" fmla="val 40000"/>
            </a:avLst>
          </a:prstGeom>
          <a:ln w="9360">
            <a:solidFill>
              <a:srgbClr val="000000"/>
            </a:solidFill>
            <a:round/>
          </a:ln>
        </p:spPr>
      </p:cxnSp>
      <p:cxnSp>
        <p:nvCxnSpPr>
          <p:cNvPr id="100" name=""/>
          <p:cNvCxnSpPr/>
          <p:nvPr/>
        </p:nvCxnSpPr>
        <p:spPr>
          <a:xfrm>
            <a:off x="8077320" y="5025600"/>
            <a:ext cx="2160" cy="724680"/>
          </a:xfrm>
          <a:prstGeom prst="bentConnector3">
            <a:avLst>
              <a:gd name="adj1" fmla="val 40000"/>
            </a:avLst>
          </a:prstGeom>
          <a:ln w="9360">
            <a:solidFill>
              <a:srgbClr val="000000"/>
            </a:solidFill>
            <a:round/>
          </a:ln>
        </p:spPr>
      </p:cxnSp>
      <p:cxnSp>
        <p:nvCxnSpPr>
          <p:cNvPr id="101" name=""/>
          <p:cNvCxnSpPr/>
          <p:nvPr/>
        </p:nvCxnSpPr>
        <p:spPr>
          <a:xfrm>
            <a:off x="8322840" y="5308560"/>
            <a:ext cx="2520" cy="43416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round/>
          </a:ln>
        </p:spPr>
      </p:cxnSp>
      <p:sp>
        <p:nvSpPr>
          <p:cNvPr id="102" name=""/>
          <p:cNvSpPr/>
          <p:nvPr/>
        </p:nvSpPr>
        <p:spPr>
          <a:xfrm>
            <a:off x="7559640" y="5045040"/>
            <a:ext cx="5493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J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n-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7866000" y="4762440"/>
            <a:ext cx="44748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J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8180640" y="5045040"/>
            <a:ext cx="45648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J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7770960" y="5837400"/>
            <a:ext cx="380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6327000" y="6280200"/>
            <a:ext cx="20840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ntact copy number is n-2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bnormal copy number is 2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7324560" y="1782720"/>
            <a:ext cx="489240" cy="311040"/>
          </a:xfrm>
          <a:prstGeom prst="rightArrow">
            <a:avLst>
              <a:gd name="adj1" fmla="val 64204"/>
              <a:gd name="adj2" fmla="val 26514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7329600" y="1854360"/>
            <a:ext cx="380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7616880" y="1719360"/>
            <a:ext cx="58680" cy="419040"/>
          </a:xfrm>
          <a:custGeom>
            <a:avLst/>
            <a:gdLst/>
            <a:ahLst/>
            <a:rect l="l" t="t" r="r" b="b"/>
            <a:pathLst>
              <a:path w="115792" h="655815">
                <a:moveTo>
                  <a:pt x="67752" y="0"/>
                </a:moveTo>
                <a:cubicBezTo>
                  <a:pt x="30446" y="87312"/>
                  <a:pt x="-6860" y="174625"/>
                  <a:pt x="1077" y="238125"/>
                </a:cubicBezTo>
                <a:cubicBezTo>
                  <a:pt x="9014" y="301625"/>
                  <a:pt x="109027" y="315913"/>
                  <a:pt x="115377" y="381000"/>
                </a:cubicBezTo>
                <a:cubicBezTo>
                  <a:pt x="121727" y="446087"/>
                  <a:pt x="53464" y="585788"/>
                  <a:pt x="39177" y="628650"/>
                </a:cubicBezTo>
                <a:cubicBezTo>
                  <a:pt x="24890" y="671512"/>
                  <a:pt x="27271" y="654843"/>
                  <a:pt x="29652" y="638175"/>
                </a:cubicBez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7342200" y="3645000"/>
            <a:ext cx="504720" cy="311040"/>
          </a:xfrm>
          <a:prstGeom prst="rightArrow">
            <a:avLst>
              <a:gd name="adj1" fmla="val 64204"/>
              <a:gd name="adj2" fmla="val 26496"/>
            </a:avLst>
          </a:prstGeom>
          <a:solidFill>
            <a:srgbClr val="f2f2f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7337520" y="3716280"/>
            <a:ext cx="380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7616880" y="3586320"/>
            <a:ext cx="58680" cy="419040"/>
          </a:xfrm>
          <a:custGeom>
            <a:avLst/>
            <a:gdLst/>
            <a:ahLst/>
            <a:rect l="l" t="t" r="r" b="b"/>
            <a:pathLst>
              <a:path w="115792" h="655815">
                <a:moveTo>
                  <a:pt x="67752" y="0"/>
                </a:moveTo>
                <a:cubicBezTo>
                  <a:pt x="30446" y="87312"/>
                  <a:pt x="-6860" y="174625"/>
                  <a:pt x="1077" y="238125"/>
                </a:cubicBezTo>
                <a:cubicBezTo>
                  <a:pt x="9014" y="301625"/>
                  <a:pt x="109027" y="315913"/>
                  <a:pt x="115377" y="381000"/>
                </a:cubicBezTo>
                <a:cubicBezTo>
                  <a:pt x="121727" y="446087"/>
                  <a:pt x="53464" y="585788"/>
                  <a:pt x="39177" y="628650"/>
                </a:cubicBezTo>
                <a:cubicBezTo>
                  <a:pt x="24890" y="671512"/>
                  <a:pt x="27271" y="654843"/>
                  <a:pt x="29652" y="638175"/>
                </a:cubicBez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6332400" y="5761080"/>
            <a:ext cx="489240" cy="312840"/>
          </a:xfrm>
          <a:prstGeom prst="rightArrow">
            <a:avLst>
              <a:gd name="adj1" fmla="val 64204"/>
              <a:gd name="adj2" fmla="val 26499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6821640" y="5761080"/>
            <a:ext cx="488880" cy="312840"/>
          </a:xfrm>
          <a:prstGeom prst="rightArrow">
            <a:avLst>
              <a:gd name="adj1" fmla="val 64204"/>
              <a:gd name="adj2" fmla="val 26479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6369120" y="5834160"/>
            <a:ext cx="380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6872400" y="5834160"/>
            <a:ext cx="380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17" name=""/>
          <p:cNvCxnSpPr/>
          <p:nvPr/>
        </p:nvCxnSpPr>
        <p:spPr>
          <a:xfrm>
            <a:off x="6334200" y="5302080"/>
            <a:ext cx="2160" cy="434160"/>
          </a:xfrm>
          <a:prstGeom prst="bentConnector3">
            <a:avLst>
              <a:gd name="adj1" fmla="val 40000"/>
            </a:avLst>
          </a:prstGeom>
          <a:ln w="9360">
            <a:solidFill>
              <a:srgbClr val="000000"/>
            </a:solidFill>
            <a:round/>
          </a:ln>
        </p:spPr>
      </p:cxnSp>
      <p:cxnSp>
        <p:nvCxnSpPr>
          <p:cNvPr id="118" name=""/>
          <p:cNvCxnSpPr/>
          <p:nvPr/>
        </p:nvCxnSpPr>
        <p:spPr>
          <a:xfrm>
            <a:off x="6831000" y="5302080"/>
            <a:ext cx="2160" cy="434160"/>
          </a:xfrm>
          <a:prstGeom prst="bentConnector3">
            <a:avLst>
              <a:gd name="adj1" fmla="val 40000"/>
            </a:avLst>
          </a:prstGeom>
          <a:ln w="9360">
            <a:solidFill>
              <a:srgbClr val="000000"/>
            </a:solidFill>
            <a:round/>
          </a:ln>
        </p:spPr>
      </p:cxnSp>
      <p:cxnSp>
        <p:nvCxnSpPr>
          <p:cNvPr id="119" name=""/>
          <p:cNvCxnSpPr/>
          <p:nvPr/>
        </p:nvCxnSpPr>
        <p:spPr>
          <a:xfrm>
            <a:off x="7334280" y="5302080"/>
            <a:ext cx="2160" cy="434160"/>
          </a:xfrm>
          <a:prstGeom prst="bentConnector3">
            <a:avLst>
              <a:gd name="adj1" fmla="val 40000"/>
            </a:avLst>
          </a:prstGeom>
          <a:ln w="9360">
            <a:solidFill>
              <a:srgbClr val="000000"/>
            </a:solidFill>
            <a:round/>
          </a:ln>
        </p:spPr>
      </p:cxnSp>
      <p:sp>
        <p:nvSpPr>
          <p:cNvPr id="120" name=""/>
          <p:cNvSpPr/>
          <p:nvPr/>
        </p:nvSpPr>
        <p:spPr>
          <a:xfrm>
            <a:off x="6185160" y="5038560"/>
            <a:ext cx="45648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J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6666120" y="5038560"/>
            <a:ext cx="45648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J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7117200" y="5038560"/>
            <a:ext cx="45648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J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7473960" y="5183280"/>
            <a:ext cx="142920" cy="1440"/>
          </a:xfrm>
          <a:prstGeom prst="line">
            <a:avLst/>
          </a:prstGeom>
          <a:ln w="1908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7321680" y="5767560"/>
            <a:ext cx="488880" cy="312480"/>
          </a:xfrm>
          <a:prstGeom prst="rightArrow">
            <a:avLst>
              <a:gd name="adj1" fmla="val 64204"/>
              <a:gd name="adj2" fmla="val 26510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7324560" y="5840280"/>
            <a:ext cx="3812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7613640" y="5705640"/>
            <a:ext cx="57240" cy="419040"/>
          </a:xfrm>
          <a:custGeom>
            <a:avLst/>
            <a:gdLst/>
            <a:ahLst/>
            <a:rect l="l" t="t" r="r" b="b"/>
            <a:pathLst>
              <a:path w="115792" h="655815">
                <a:moveTo>
                  <a:pt x="67752" y="0"/>
                </a:moveTo>
                <a:cubicBezTo>
                  <a:pt x="30446" y="87312"/>
                  <a:pt x="-6860" y="174625"/>
                  <a:pt x="1077" y="238125"/>
                </a:cubicBezTo>
                <a:cubicBezTo>
                  <a:pt x="9014" y="301625"/>
                  <a:pt x="109027" y="315913"/>
                  <a:pt x="115377" y="381000"/>
                </a:cubicBezTo>
                <a:cubicBezTo>
                  <a:pt x="121727" y="446087"/>
                  <a:pt x="53464" y="585788"/>
                  <a:pt x="39177" y="628650"/>
                </a:cubicBezTo>
                <a:cubicBezTo>
                  <a:pt x="24890" y="671512"/>
                  <a:pt x="27271" y="654843"/>
                  <a:pt x="29652" y="638175"/>
                </a:cubicBez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 flipV="1" rot="16200000">
            <a:off x="7191360" y="5241960"/>
            <a:ext cx="233280" cy="1967040"/>
          </a:xfrm>
          <a:custGeom>
            <a:avLst/>
            <a:gdLst>
              <a:gd name="textAreaLeft" fmla="*/ 149040 w 233280"/>
              <a:gd name="textAreaRight" fmla="*/ 233640 w 233280"/>
              <a:gd name="textAreaTop" fmla="*/ 15480 h 1967040"/>
              <a:gd name="textAreaBottom" fmla="*/ 1951560 h 19670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273"/>
                  <a:pt x="10800" y="546"/>
                </a:cubicBezTo>
                <a:lnTo>
                  <a:pt x="10800" y="10254"/>
                </a:lnTo>
                <a:cubicBezTo>
                  <a:pt x="10800" y="10527"/>
                  <a:pt x="5400" y="10800"/>
                  <a:pt x="0" y="10800"/>
                </a:cubicBezTo>
                <a:cubicBezTo>
                  <a:pt x="5400" y="10800"/>
                  <a:pt x="10800" y="11073"/>
                  <a:pt x="10800" y="11346"/>
                </a:cubicBezTo>
                <a:lnTo>
                  <a:pt x="10800" y="21054"/>
                </a:lnTo>
                <a:cubicBezTo>
                  <a:pt x="10800" y="21327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423720" y="1332000"/>
            <a:ext cx="34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1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428400" y="3062160"/>
            <a:ext cx="34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2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428400" y="4869000"/>
            <a:ext cx="34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3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704880" y="5923080"/>
            <a:ext cx="47530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85680" indent="-84240">
              <a:tabLst>
                <a:tab algn="l" pos="0"/>
                <a:tab algn="l" pos="85680"/>
                <a:tab algn="l" pos="1000080"/>
                <a:tab algn="l" pos="1914480"/>
                <a:tab algn="l" pos="2828880"/>
                <a:tab algn="l" pos="3743280"/>
                <a:tab algn="l" pos="4657680"/>
                <a:tab algn="l" pos="5572080"/>
                <a:tab algn="l" pos="6486480"/>
                <a:tab algn="l" pos="7400880"/>
                <a:tab algn="l" pos="8315280"/>
                <a:tab algn="l" pos="9229680"/>
                <a:tab algn="l" pos="1014408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Upstream and downstream junctions are fixed at the chromosomal integration sites, so these two abnormal junctions are not included in this calculatio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73080" y="66600"/>
            <a:ext cx="1320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uppl. Fig. 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7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10T03:26:47Z</dcterms:created>
  <dc:creator>dgm2</dc:creator>
  <dc:description/>
  <dc:language>en-US</dc:language>
  <cp:lastModifiedBy>masumura</cp:lastModifiedBy>
  <cp:lastPrinted>2015-08-31T08:41:32Z</cp:lastPrinted>
  <dcterms:modified xsi:type="dcterms:W3CDTF">2015-10-01T07:44:08Z</dcterms:modified>
  <cp:revision>260</cp:revision>
  <dc:subject/>
  <dc:title>スライド 1</dc:title>
</cp:coreProperties>
</file>